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3" r:id="rId2"/>
    <p:sldId id="294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9692D49-F068-4827-B558-D99567450BF4}" v="12" dt="2022-08-22T13:02:11.17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C9E7F7-BC5A-4A97-2A59-32772B667C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17C9340-94D2-FCB4-A3EB-75AC3CBE61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9291386-2BF9-2FA9-17AD-3A5967221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7970B8-6CE4-F52F-B196-6111F21BB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F43E8F-1F4D-5ABD-915F-094E00AAB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625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D29A19-A2A4-A3AA-2B4D-8AC5712208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99817E7-121D-EB6D-336F-16E28AA0F6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FC01B2-43D4-3F02-4E22-F325BE243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9DB26A3-8ABB-BBED-C68D-AC0BC2C334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CEE758-ABCC-4BF4-70C5-C5ED74FC8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550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D0787BD-AFE5-07E7-7480-3272B85AA3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485B743-AB7B-A1A8-8A9D-ED6A8107AE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304F3D-D0D7-EC67-1581-E0286E835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5E30E9-1541-41C2-1102-B27DC451C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583BF13-5E07-5D12-F225-8B332213C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8499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AE6DB0-B297-56A5-818A-7C4456BB56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1CE7465-7C6F-3FCE-1748-A43E96CC9A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B06258D-B0F1-C1BC-BCA7-A9BBD3D8A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68CF11-2C98-C851-3E86-C57A67639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6B1D8E-AEF2-8551-72BD-01693FE18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5416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C20EF2-68FB-1468-67A6-2F05FF8275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339231C-5352-C286-1F4C-AE98A0EE25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EF8F056-7C1F-32C8-768E-151D5001FD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97A9E22-1507-5752-A63E-68C220198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6B429B-E316-32D9-016D-665BD8CCB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8462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15A3E2-CE70-C65A-306F-26D9E7F646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C9E2D2A-6B42-BE9C-E2CD-ED7AC1AA2C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C529CAB-D14E-59DE-0D55-6ABF896AFA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3BCCF98-E528-0FE3-F041-43A6CC5530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1CAC731-B22B-F494-E1D4-35F880AFD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E8AC6FF-D194-A631-B36B-E28698ED9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4570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E8ABB4-88DB-08D3-B6EE-D53FE276C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97BF33-ED36-FF61-B299-29C8E126B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C6AA2FE-A83B-B77F-B168-5D9E51205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370EA44-5456-5CA4-B7C2-59E5528ACB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2801D83-E5B0-55C6-8960-227E993B3B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4C7676B-B836-BDB7-F170-EA0909397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C61CA87-53B1-5091-D6AA-154A27348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630A96B-0C16-D2E3-5AD9-4F4982B95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818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1F10CF-2427-6546-495A-0FB72791A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B6D8989-695B-7BBD-965D-2012A5260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DE79352-A26D-F4B9-6C64-2F495399E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CED8B41-CB03-8A13-F1CB-8D4217FF1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448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059C731-4685-61B8-554A-0963AAF7F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086B04F-EDB6-531F-B97F-C47B49119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12815F7-F25D-D5CC-F01A-290EEBCC5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5630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687D7F-E797-9206-8DE9-EE3EC457F2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D94982-7127-9267-A0F3-E6EE1B8F29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0A17837-44A4-F2CC-941A-73C177CB70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25A8B48-408C-0A8F-F7E1-2179758CD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2199C45-C048-E657-527F-6FF53FF41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F38A79-459D-D75B-2D95-06867B0C7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2943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3476DC-C838-B604-9FBB-39213164B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5F983DF-4E0F-8D21-47AC-BC51169CA6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666B102-52DD-D26A-8393-93CC7FFEAD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EAAF2E5-983D-AA0C-4749-40A15554E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B9EDFCB-128E-C160-27A1-07F0B82CD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7E4CBBC-A121-A64B-CBE8-8AF6E36A6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5423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E34E6BE-87F3-CBD4-AD4E-E389238C9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3FCC4D8-E8DC-A371-D91E-4B15959B83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F7BFAE-8FD6-4B0C-09CC-1D7B01A31F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B09CB6-3486-4991-8D21-67172DADE7EB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2D7012-BC0A-0CF5-5DA3-3138BF5072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3AA47E-E244-4649-86CE-638A329AB0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6C091-169E-4119-8908-C7AF8B224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876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B0FF594F-1EC2-2AF1-B7C2-D76927916A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0804" y="431957"/>
            <a:ext cx="4677688" cy="4677688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651461D-65EB-4BA0-83A3-106151CFEA7E}"/>
              </a:ext>
            </a:extLst>
          </p:cNvPr>
          <p:cNvSpPr txBox="1"/>
          <p:nvPr/>
        </p:nvSpPr>
        <p:spPr>
          <a:xfrm>
            <a:off x="5051092" y="1220710"/>
            <a:ext cx="1021080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0-1</a:t>
            </a:r>
          </a:p>
          <a:p>
            <a:r>
              <a:rPr kumimoji="1" lang="en-US" altLang="ja-JP" sz="1000" dirty="0"/>
              <a:t>2-3</a:t>
            </a:r>
          </a:p>
          <a:p>
            <a:r>
              <a:rPr lang="ja-JP" altLang="en-US" sz="1000" dirty="0"/>
              <a:t>≥ </a:t>
            </a:r>
            <a:r>
              <a:rPr lang="en-US" altLang="ja-JP" sz="1000" dirty="0"/>
              <a:t>4</a:t>
            </a:r>
            <a:endParaRPr kumimoji="1" lang="ja-JP" altLang="en-US" sz="10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4AF6C2B-B818-0529-45D4-C10E1304CCD9}"/>
              </a:ext>
            </a:extLst>
          </p:cNvPr>
          <p:cNvSpPr txBox="1"/>
          <p:nvPr/>
        </p:nvSpPr>
        <p:spPr>
          <a:xfrm>
            <a:off x="3228368" y="2069221"/>
            <a:ext cx="19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/>
              <a:t>P </a:t>
            </a:r>
            <a:r>
              <a:rPr kumimoji="1" lang="en-US" altLang="ja-JP" sz="1000" dirty="0"/>
              <a:t>&lt;0.001</a:t>
            </a:r>
            <a:endParaRPr kumimoji="1" lang="ja-JP" altLang="en-US" sz="10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8AC4C81-A9B9-46FD-FE94-D83B622117F1}"/>
              </a:ext>
            </a:extLst>
          </p:cNvPr>
          <p:cNvSpPr txBox="1"/>
          <p:nvPr/>
        </p:nvSpPr>
        <p:spPr>
          <a:xfrm>
            <a:off x="806148" y="4527273"/>
            <a:ext cx="1021080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/>
              <a:t>0-1</a:t>
            </a:r>
          </a:p>
          <a:p>
            <a:pPr algn="r"/>
            <a:r>
              <a:rPr kumimoji="1" lang="en-US" altLang="ja-JP" sz="1000" dirty="0"/>
              <a:t>2-3</a:t>
            </a:r>
          </a:p>
          <a:p>
            <a:pPr algn="r"/>
            <a:r>
              <a:rPr lang="ja-JP" altLang="en-US" sz="1000" dirty="0"/>
              <a:t>≥ </a:t>
            </a:r>
            <a:r>
              <a:rPr lang="en-US" altLang="ja-JP" sz="1000" dirty="0"/>
              <a:t>4</a:t>
            </a:r>
            <a:endParaRPr kumimoji="1" lang="ja-JP" altLang="en-US" sz="1000" dirty="0"/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E81B0192-4BA0-BAD6-947F-323DB15F0A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4461" y="435541"/>
            <a:ext cx="4757029" cy="4757029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A5E6ACA-2D05-0F65-3940-CC9E4E8F93AA}"/>
              </a:ext>
            </a:extLst>
          </p:cNvPr>
          <p:cNvSpPr txBox="1"/>
          <p:nvPr/>
        </p:nvSpPr>
        <p:spPr>
          <a:xfrm>
            <a:off x="10294863" y="1239547"/>
            <a:ext cx="1021080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0-1</a:t>
            </a:r>
          </a:p>
          <a:p>
            <a:r>
              <a:rPr kumimoji="1" lang="en-US" altLang="ja-JP" sz="1000" dirty="0"/>
              <a:t>2-3</a:t>
            </a:r>
          </a:p>
          <a:p>
            <a:r>
              <a:rPr lang="ja-JP" altLang="en-US" sz="1000" dirty="0"/>
              <a:t>≥ </a:t>
            </a:r>
            <a:r>
              <a:rPr lang="en-US" altLang="ja-JP" sz="1000" dirty="0"/>
              <a:t>4</a:t>
            </a:r>
            <a:endParaRPr kumimoji="1" lang="ja-JP" altLang="en-US" sz="10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993A134-C996-23E1-7389-75A125DD1EC0}"/>
              </a:ext>
            </a:extLst>
          </p:cNvPr>
          <p:cNvSpPr txBox="1"/>
          <p:nvPr/>
        </p:nvSpPr>
        <p:spPr>
          <a:xfrm>
            <a:off x="6054527" y="4618027"/>
            <a:ext cx="1021080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/>
              <a:t>0-1</a:t>
            </a:r>
          </a:p>
          <a:p>
            <a:pPr algn="r"/>
            <a:r>
              <a:rPr kumimoji="1" lang="en-US" altLang="ja-JP" sz="1000" dirty="0"/>
              <a:t>2-3</a:t>
            </a:r>
          </a:p>
          <a:p>
            <a:pPr algn="r"/>
            <a:r>
              <a:rPr lang="ja-JP" altLang="en-US" sz="1000" dirty="0"/>
              <a:t>≥ </a:t>
            </a:r>
            <a:r>
              <a:rPr lang="en-US" altLang="ja-JP" sz="1000" dirty="0"/>
              <a:t>4</a:t>
            </a:r>
            <a:endParaRPr kumimoji="1" lang="ja-JP" altLang="en-US" sz="10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48C6670-60B8-9AAA-A75F-3E2FEC05FE10}"/>
              </a:ext>
            </a:extLst>
          </p:cNvPr>
          <p:cNvSpPr txBox="1"/>
          <p:nvPr/>
        </p:nvSpPr>
        <p:spPr>
          <a:xfrm>
            <a:off x="8654058" y="2069617"/>
            <a:ext cx="19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/>
              <a:t>P </a:t>
            </a:r>
            <a:r>
              <a:rPr kumimoji="1" lang="en-US" altLang="ja-JP" sz="1000" dirty="0"/>
              <a:t>=0.271</a:t>
            </a:r>
            <a:endParaRPr kumimoji="1" lang="ja-JP" altLang="en-US" sz="10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A66DF4F-05B2-7257-00AF-9CC9DD0A41B6}"/>
              </a:ext>
            </a:extLst>
          </p:cNvPr>
          <p:cNvSpPr txBox="1"/>
          <p:nvPr/>
        </p:nvSpPr>
        <p:spPr>
          <a:xfrm>
            <a:off x="1552212" y="5612581"/>
            <a:ext cx="951771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aplan–Meier curves for overall survival in patients with (A) and without sarcopenia (B) according to the controlling nutritional status (CONUT) score. </a:t>
            </a:r>
            <a:endParaRPr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8F48304-BBE5-85A0-884A-D2882145A093}"/>
              </a:ext>
            </a:extLst>
          </p:cNvPr>
          <p:cNvSpPr txBox="1"/>
          <p:nvPr/>
        </p:nvSpPr>
        <p:spPr>
          <a:xfrm flipH="1">
            <a:off x="3031552" y="1013259"/>
            <a:ext cx="165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Sarcopenia+</a:t>
            </a:r>
            <a:endParaRPr kumimoji="1" lang="ja-JP" altLang="en-US" sz="1200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87ECE86-F72D-E80F-3ECC-1B7E34575AF8}"/>
              </a:ext>
            </a:extLst>
          </p:cNvPr>
          <p:cNvSpPr txBox="1"/>
          <p:nvPr/>
        </p:nvSpPr>
        <p:spPr>
          <a:xfrm flipH="1">
            <a:off x="1112260" y="551594"/>
            <a:ext cx="408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F8E31B2-52B0-8B17-63E0-2CF79EA4AC87}"/>
              </a:ext>
            </a:extLst>
          </p:cNvPr>
          <p:cNvSpPr txBox="1"/>
          <p:nvPr/>
        </p:nvSpPr>
        <p:spPr>
          <a:xfrm flipH="1">
            <a:off x="6360639" y="551594"/>
            <a:ext cx="408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B</a:t>
            </a:r>
            <a:endParaRPr kumimoji="1" lang="ja-JP" altLang="en-US" sz="2400" b="1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E8BCF11-3FE7-94C4-4029-33F3A3B9058D}"/>
              </a:ext>
            </a:extLst>
          </p:cNvPr>
          <p:cNvSpPr txBox="1"/>
          <p:nvPr/>
        </p:nvSpPr>
        <p:spPr>
          <a:xfrm flipH="1">
            <a:off x="8459614" y="1009457"/>
            <a:ext cx="165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Sarcopenia-</a:t>
            </a:r>
            <a:endParaRPr kumimoji="1" lang="ja-JP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088960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C324F5B6-51BE-8312-EC68-5724E30AE2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5830" y="460375"/>
            <a:ext cx="4900930" cy="490093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EF128CA-E8A2-CD43-3F20-9DE0B9D8B01E}"/>
              </a:ext>
            </a:extLst>
          </p:cNvPr>
          <p:cNvSpPr txBox="1"/>
          <p:nvPr/>
        </p:nvSpPr>
        <p:spPr>
          <a:xfrm>
            <a:off x="5242560" y="1280160"/>
            <a:ext cx="1402080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00" dirty="0"/>
              <a:t>Absence</a:t>
            </a:r>
          </a:p>
          <a:p>
            <a:r>
              <a:rPr lang="en-US" altLang="ja-JP" sz="1000" dirty="0"/>
              <a:t>P</a:t>
            </a:r>
            <a:r>
              <a:rPr kumimoji="1" lang="en-US" altLang="ja-JP" sz="1000" dirty="0"/>
              <a:t>resence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7D6887E-0789-CB61-0C47-54E2A92BAA63}"/>
              </a:ext>
            </a:extLst>
          </p:cNvPr>
          <p:cNvSpPr txBox="1"/>
          <p:nvPr/>
        </p:nvSpPr>
        <p:spPr>
          <a:xfrm>
            <a:off x="355600" y="4907280"/>
            <a:ext cx="1402080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dirty="0"/>
              <a:t>Absence</a:t>
            </a:r>
          </a:p>
          <a:p>
            <a:pPr algn="r"/>
            <a:r>
              <a:rPr lang="en-US" altLang="ja-JP" sz="1000" dirty="0"/>
              <a:t>P</a:t>
            </a:r>
            <a:r>
              <a:rPr kumimoji="1" lang="en-US" altLang="ja-JP" sz="1000" dirty="0"/>
              <a:t>resence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FD69651-5CE1-3C83-9A09-E91F45298CCF}"/>
              </a:ext>
            </a:extLst>
          </p:cNvPr>
          <p:cNvSpPr txBox="1"/>
          <p:nvPr/>
        </p:nvSpPr>
        <p:spPr>
          <a:xfrm>
            <a:off x="3563648" y="2384181"/>
            <a:ext cx="19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/>
              <a:t>P </a:t>
            </a:r>
            <a:r>
              <a:rPr kumimoji="1" lang="en-US" altLang="ja-JP" sz="1000" dirty="0"/>
              <a:t>=0.039</a:t>
            </a:r>
            <a:endParaRPr kumimoji="1" lang="ja-JP" altLang="en-US" sz="1000" dirty="0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B3199373-F3F6-6FD9-757C-3B2B2596E3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9830" y="472272"/>
            <a:ext cx="4900930" cy="490093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D8F69C7-89C8-7DC0-4364-A9C56F52CA7D}"/>
              </a:ext>
            </a:extLst>
          </p:cNvPr>
          <p:cNvSpPr txBox="1"/>
          <p:nvPr/>
        </p:nvSpPr>
        <p:spPr>
          <a:xfrm>
            <a:off x="10565130" y="1310640"/>
            <a:ext cx="1402080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00" dirty="0"/>
              <a:t>Absence</a:t>
            </a:r>
          </a:p>
          <a:p>
            <a:r>
              <a:rPr lang="en-US" altLang="ja-JP" sz="1000" dirty="0"/>
              <a:t>P</a:t>
            </a:r>
            <a:r>
              <a:rPr kumimoji="1" lang="en-US" altLang="ja-JP" sz="1000" dirty="0"/>
              <a:t>resence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02508C0-D2C2-7914-30E9-785A9CAB03EB}"/>
              </a:ext>
            </a:extLst>
          </p:cNvPr>
          <p:cNvSpPr txBox="1"/>
          <p:nvPr/>
        </p:nvSpPr>
        <p:spPr>
          <a:xfrm>
            <a:off x="5746750" y="4935296"/>
            <a:ext cx="1402080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dirty="0"/>
              <a:t>Absence</a:t>
            </a:r>
          </a:p>
          <a:p>
            <a:pPr algn="r"/>
            <a:r>
              <a:rPr lang="en-US" altLang="ja-JP" sz="1000" dirty="0"/>
              <a:t>P</a:t>
            </a:r>
            <a:r>
              <a:rPr kumimoji="1" lang="en-US" altLang="ja-JP" sz="1000" dirty="0"/>
              <a:t>resence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06C8712-ABDA-6418-7FC4-84F3D1455298}"/>
              </a:ext>
            </a:extLst>
          </p:cNvPr>
          <p:cNvSpPr txBox="1"/>
          <p:nvPr/>
        </p:nvSpPr>
        <p:spPr>
          <a:xfrm>
            <a:off x="8710295" y="2384181"/>
            <a:ext cx="19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/>
              <a:t>P </a:t>
            </a:r>
            <a:r>
              <a:rPr kumimoji="1" lang="en-US" altLang="ja-JP" sz="1000" dirty="0"/>
              <a:t>=0.394</a:t>
            </a:r>
            <a:endParaRPr kumimoji="1" lang="ja-JP" altLang="en-US" sz="10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9804ECD-B7D9-B2F6-AC3A-A60CF90198BD}"/>
              </a:ext>
            </a:extLst>
          </p:cNvPr>
          <p:cNvSpPr txBox="1"/>
          <p:nvPr/>
        </p:nvSpPr>
        <p:spPr>
          <a:xfrm flipH="1">
            <a:off x="2811693" y="1033641"/>
            <a:ext cx="2035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The CONUT score 0-3</a:t>
            </a:r>
            <a:endParaRPr kumimoji="1" lang="ja-JP" altLang="en-US" sz="1200" b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43A405B-3B9D-3AC7-F9C4-40AA6E288054}"/>
              </a:ext>
            </a:extLst>
          </p:cNvPr>
          <p:cNvSpPr txBox="1"/>
          <p:nvPr/>
        </p:nvSpPr>
        <p:spPr>
          <a:xfrm flipH="1">
            <a:off x="8167060" y="1012728"/>
            <a:ext cx="2398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The CONUT score ≥4 </a:t>
            </a:r>
            <a:endParaRPr kumimoji="1" lang="ja-JP" altLang="en-US" sz="1200" b="1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5F878C3-C996-8265-DEA0-6C51827F941D}"/>
              </a:ext>
            </a:extLst>
          </p:cNvPr>
          <p:cNvSpPr txBox="1"/>
          <p:nvPr/>
        </p:nvSpPr>
        <p:spPr>
          <a:xfrm>
            <a:off x="691988" y="5931769"/>
            <a:ext cx="1113568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altLang="ja-JP" sz="18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aplan</a:t>
            </a:r>
            <a:r>
              <a:rPr lang="zh-CN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–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ier curves of overall survival in patients with the CONUT score 0-3 (A) and </a:t>
            </a:r>
            <a:r>
              <a:rPr lang="ja-JP" altLang="ja-JP" sz="1800" dirty="0">
                <a:solidFill>
                  <a:srgbClr val="000000"/>
                </a:solidFill>
                <a:effectLst/>
                <a:ea typeface="游明朝" panose="02020400000000000000" pitchFamily="18" charset="-128"/>
                <a:cs typeface="Times New Roman" panose="02020603050405020304" pitchFamily="18" charset="0"/>
              </a:rPr>
              <a:t>≥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4 (B) according to the presence or absence of sarcopenia.</a:t>
            </a:r>
            <a:endParaRPr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57FD5C3-3357-5490-F3C3-82217118947A}"/>
              </a:ext>
            </a:extLst>
          </p:cNvPr>
          <p:cNvSpPr txBox="1"/>
          <p:nvPr/>
        </p:nvSpPr>
        <p:spPr>
          <a:xfrm flipH="1">
            <a:off x="925830" y="639435"/>
            <a:ext cx="408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210E4CC-AE45-A493-DDAF-0FC91F3013FE}"/>
              </a:ext>
            </a:extLst>
          </p:cNvPr>
          <p:cNvSpPr txBox="1"/>
          <p:nvPr/>
        </p:nvSpPr>
        <p:spPr>
          <a:xfrm flipH="1">
            <a:off x="6259830" y="639435"/>
            <a:ext cx="408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B</a:t>
            </a:r>
            <a:endParaRPr kumimoji="1" lang="ja-JP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2364879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0</TotalTime>
  <Words>122</Words>
  <Application>Microsoft Office PowerPoint</Application>
  <PresentationFormat>Widescreen</PresentationFormat>
  <Paragraphs>3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0" baseType="lpstr">
      <vt:lpstr>游ゴシック</vt:lpstr>
      <vt:lpstr>游ゴシック Light</vt:lpstr>
      <vt:lpstr>游明朝</vt:lpstr>
      <vt:lpstr>SimSun</vt:lpstr>
      <vt:lpstr>Arial</vt:lpstr>
      <vt:lpstr>Palatino Linotype</vt:lpstr>
      <vt:lpstr>Times New Roman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ne Minami</dc:creator>
  <cp:lastModifiedBy>MDPI</cp:lastModifiedBy>
  <cp:revision>3</cp:revision>
  <dcterms:created xsi:type="dcterms:W3CDTF">2022-08-21T14:01:56Z</dcterms:created>
  <dcterms:modified xsi:type="dcterms:W3CDTF">2022-10-17T03:25:32Z</dcterms:modified>
</cp:coreProperties>
</file>